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18" autoAdjust="0"/>
    <p:restoredTop sz="94660"/>
  </p:normalViewPr>
  <p:slideViewPr>
    <p:cSldViewPr snapToGrid="0">
      <p:cViewPr varScale="1">
        <p:scale>
          <a:sx n="97" d="100"/>
          <a:sy n="97" d="100"/>
        </p:scale>
        <p:origin x="108" y="9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DE73A-3640-401C-9710-737F402632F0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E2737-F856-4CB4-954F-EC065A3E96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3359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DE73A-3640-401C-9710-737F402632F0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E2737-F856-4CB4-954F-EC065A3E96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6004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DE73A-3640-401C-9710-737F402632F0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E2737-F856-4CB4-954F-EC065A3E96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40372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DE73A-3640-401C-9710-737F402632F0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E2737-F856-4CB4-954F-EC065A3E96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30430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DE73A-3640-401C-9710-737F402632F0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E2737-F856-4CB4-954F-EC065A3E96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76536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DE73A-3640-401C-9710-737F402632F0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E2737-F856-4CB4-954F-EC065A3E96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84464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DE73A-3640-401C-9710-737F402632F0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E2737-F856-4CB4-954F-EC065A3E96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3043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DE73A-3640-401C-9710-737F402632F0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E2737-F856-4CB4-954F-EC065A3E96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10935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DE73A-3640-401C-9710-737F402632F0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E2737-F856-4CB4-954F-EC065A3E96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59739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DE73A-3640-401C-9710-737F402632F0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E2737-F856-4CB4-954F-EC065A3E96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73384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DE73A-3640-401C-9710-737F402632F0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E2737-F856-4CB4-954F-EC065A3E96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63939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9DE73A-3640-401C-9710-737F402632F0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DE2737-F856-4CB4-954F-EC065A3E96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87134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Manufacturing instructions for the OLED display </a:t>
            </a:r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75271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Part lists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dirty="0" smtClean="0"/>
              <a:t>3.8 inch OLED display module (TF381010A-V0) x 2</a:t>
            </a:r>
          </a:p>
          <a:p>
            <a:r>
              <a:rPr lang="en-US" dirty="0" smtClean="0"/>
              <a:t>HDMI to MIPI convertor board</a:t>
            </a:r>
          </a:p>
          <a:p>
            <a:r>
              <a:rPr lang="en-US" dirty="0" smtClean="0"/>
              <a:t>HDMI optic cable (HD4K-FO-20M-MM)</a:t>
            </a:r>
          </a:p>
          <a:p>
            <a:r>
              <a:rPr lang="en-US" dirty="0" smtClean="0"/>
              <a:t>Non-magnetic battery (PGEB-NM5858138-PCB)</a:t>
            </a:r>
          </a:p>
          <a:p>
            <a:r>
              <a:rPr lang="en-US" dirty="0" smtClean="0"/>
              <a:t>Copper tape</a:t>
            </a:r>
          </a:p>
          <a:p>
            <a:r>
              <a:rPr lang="en-US" dirty="0" smtClean="0"/>
              <a:t>3D CAD file : y_ko_display_part1_ver2, y_ko_display_part2, y_ko_display_part3, y_ko_display_part4, </a:t>
            </a:r>
            <a:r>
              <a:rPr lang="en-US" dirty="0" smtClean="0"/>
              <a:t>y_ko_display_part5, </a:t>
            </a:r>
            <a:r>
              <a:rPr lang="en-US" dirty="0" err="1" smtClean="0"/>
              <a:t>y_ko_display_part_cover_HDMI</a:t>
            </a:r>
            <a:r>
              <a:rPr lang="en-US" dirty="0" smtClean="0"/>
              <a:t>, y_ko_display_part7, 4pin_connector_female</a:t>
            </a:r>
          </a:p>
          <a:p>
            <a:r>
              <a:rPr lang="en-US" dirty="0" smtClean="0"/>
              <a:t>Conductive mesh (8900) </a:t>
            </a:r>
          </a:p>
          <a:p>
            <a:r>
              <a:rPr lang="en-US" dirty="0" smtClean="0"/>
              <a:t>Acrylic panel: 150 x 90 mm</a:t>
            </a:r>
            <a:endParaRPr lang="en-GB" dirty="0" smtClean="0"/>
          </a:p>
          <a:p>
            <a:endParaRPr lang="en-GB" dirty="0" smtClean="0"/>
          </a:p>
          <a:p>
            <a:endParaRPr lang="en-GB" dirty="0" smtClean="0"/>
          </a:p>
          <a:p>
            <a:pPr marL="0" indent="0">
              <a:buNone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70977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ep 1. Replace ferrite inductor 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Replace ferrite inductor and connect the display and converter board</a:t>
            </a:r>
            <a:endParaRPr lang="en-GB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16642" y="2518834"/>
            <a:ext cx="3295650" cy="3429000"/>
          </a:xfrm>
          <a:prstGeom prst="rect">
            <a:avLst/>
          </a:prstGeom>
        </p:spPr>
      </p:pic>
      <p:sp>
        <p:nvSpPr>
          <p:cNvPr id="6" name="Oval 5"/>
          <p:cNvSpPr/>
          <p:nvPr/>
        </p:nvSpPr>
        <p:spPr>
          <a:xfrm>
            <a:off x="2844800" y="3937000"/>
            <a:ext cx="804333" cy="575733"/>
          </a:xfrm>
          <a:prstGeom prst="ellipse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8" name="Straight Arrow Connector 7"/>
          <p:cNvCxnSpPr/>
          <p:nvPr/>
        </p:nvCxnSpPr>
        <p:spPr>
          <a:xfrm flipH="1">
            <a:off x="3657601" y="4039985"/>
            <a:ext cx="2768137" cy="748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450417" y="3631962"/>
            <a:ext cx="65416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errite inductor have to be replaced with the non-magnetic inductor</a:t>
            </a:r>
            <a:endParaRPr lang="en-GB" dirty="0"/>
          </a:p>
        </p:txBody>
      </p:sp>
      <p:cxnSp>
        <p:nvCxnSpPr>
          <p:cNvPr id="11" name="Straight Arrow Connector 10"/>
          <p:cNvCxnSpPr/>
          <p:nvPr/>
        </p:nvCxnSpPr>
        <p:spPr>
          <a:xfrm flipH="1">
            <a:off x="3981798" y="3050771"/>
            <a:ext cx="2211184" cy="13269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5733049" y="2743124"/>
            <a:ext cx="46063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onnect the OLED module using this connector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483317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ep 2. 3D printing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3D printing all files: y_ko_display_part1_ver2, y_ko_display_part2, y_ko_display_part3, y_ko_display_part4, y_ko_display_part5, </a:t>
            </a:r>
            <a:r>
              <a:rPr lang="en-US" dirty="0" err="1" smtClean="0"/>
              <a:t>y_ko_display_part_cover_HDMI</a:t>
            </a:r>
            <a:r>
              <a:rPr lang="en-US" dirty="0" smtClean="0"/>
              <a:t>, y_ko_display_part7, 4pin_connector_female</a:t>
            </a:r>
          </a:p>
          <a:p>
            <a:endParaRPr lang="en-GB" dirty="0" smtClean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417164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5230" y="3626402"/>
            <a:ext cx="3726486" cy="2520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ep 3. Tapping	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Assemble y_ko_display_part1 and y_ko_display_part2, 4pin_connector_female</a:t>
            </a:r>
          </a:p>
          <a:p>
            <a:r>
              <a:rPr lang="en-US" dirty="0" smtClean="0"/>
              <a:t>Attach a copper tape to the inside of the printed shield box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43416" y="3257070"/>
            <a:ext cx="9168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apping</a:t>
            </a:r>
            <a:endParaRPr lang="en-GB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45725" y="3441736"/>
            <a:ext cx="3519380" cy="2844000"/>
          </a:xfrm>
          <a:prstGeom prst="rect">
            <a:avLst/>
          </a:prstGeom>
        </p:spPr>
      </p:pic>
      <p:cxnSp>
        <p:nvCxnSpPr>
          <p:cNvPr id="12" name="Straight Arrow Connector 11"/>
          <p:cNvCxnSpPr/>
          <p:nvPr/>
        </p:nvCxnSpPr>
        <p:spPr>
          <a:xfrm>
            <a:off x="6991004" y="3782558"/>
            <a:ext cx="1521229" cy="543199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 flipH="1">
            <a:off x="3510116" y="3626402"/>
            <a:ext cx="2743200" cy="601467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9004014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5230" y="3626402"/>
            <a:ext cx="3726486" cy="2520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ep 4: Assemble 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Put the conductive mesh and acrylic panel</a:t>
            </a:r>
          </a:p>
          <a:p>
            <a:r>
              <a:rPr lang="en-US" dirty="0" smtClean="0"/>
              <a:t>Put the display module</a:t>
            </a:r>
          </a:p>
          <a:p>
            <a:r>
              <a:rPr lang="en-US" dirty="0" smtClean="0"/>
              <a:t>Assemble the y_ko_display_part3</a:t>
            </a:r>
          </a:p>
          <a:p>
            <a:endParaRPr lang="en-GB" dirty="0"/>
          </a:p>
        </p:txBody>
      </p:sp>
      <p:cxnSp>
        <p:nvCxnSpPr>
          <p:cNvPr id="6" name="Straight Arrow Connector 5"/>
          <p:cNvCxnSpPr>
            <a:stCxn id="7" idx="2"/>
          </p:cNvCxnSpPr>
          <p:nvPr/>
        </p:nvCxnSpPr>
        <p:spPr>
          <a:xfrm flipH="1">
            <a:off x="3815543" y="3684054"/>
            <a:ext cx="1498814" cy="1022289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3582857" y="3314722"/>
            <a:ext cx="3462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onductive mesh and acrylic panel </a:t>
            </a:r>
            <a:endParaRPr lang="en-GB" dirty="0"/>
          </a:p>
        </p:txBody>
      </p:sp>
      <p:cxnSp>
        <p:nvCxnSpPr>
          <p:cNvPr id="12" name="Straight Arrow Connector 11"/>
          <p:cNvCxnSpPr/>
          <p:nvPr/>
        </p:nvCxnSpPr>
        <p:spPr>
          <a:xfrm flipV="1">
            <a:off x="5169248" y="5220393"/>
            <a:ext cx="1805130" cy="0"/>
          </a:xfrm>
          <a:prstGeom prst="straightConnector1">
            <a:avLst/>
          </a:prstGeom>
          <a:ln w="412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Picture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04436" y="3656963"/>
            <a:ext cx="3719306" cy="25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08541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ep 5: Assemb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Put the non-magnetic battery</a:t>
            </a:r>
          </a:p>
          <a:p>
            <a:r>
              <a:rPr lang="en-US" dirty="0" smtClean="0"/>
              <a:t>Assemble the y_ko_display_part4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4972102" y="3781239"/>
            <a:ext cx="2247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on-magnetic battery</a:t>
            </a:r>
            <a:endParaRPr lang="en-GB" dirty="0"/>
          </a:p>
        </p:txBody>
      </p:sp>
      <p:sp>
        <p:nvSpPr>
          <p:cNvPr id="12" name="TextBox 11"/>
          <p:cNvSpPr txBox="1"/>
          <p:nvPr/>
        </p:nvSpPr>
        <p:spPr>
          <a:xfrm>
            <a:off x="7612063" y="2663708"/>
            <a:ext cx="2017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Y_ko_display_part4</a:t>
            </a:r>
            <a:endParaRPr lang="en-GB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7626" y="3656963"/>
            <a:ext cx="3719306" cy="2520000"/>
          </a:xfrm>
          <a:prstGeom prst="rect">
            <a:avLst/>
          </a:prstGeom>
        </p:spPr>
      </p:pic>
      <p:cxnSp>
        <p:nvCxnSpPr>
          <p:cNvPr id="6" name="Straight Arrow Connector 5"/>
          <p:cNvCxnSpPr/>
          <p:nvPr/>
        </p:nvCxnSpPr>
        <p:spPr>
          <a:xfrm flipH="1">
            <a:off x="3510116" y="4218039"/>
            <a:ext cx="1750142" cy="39230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Picture 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19897" y="3580630"/>
            <a:ext cx="3759087" cy="2520000"/>
          </a:xfrm>
          <a:prstGeom prst="rect">
            <a:avLst/>
          </a:prstGeom>
        </p:spPr>
      </p:pic>
      <p:cxnSp>
        <p:nvCxnSpPr>
          <p:cNvPr id="11" name="Straight Arrow Connector 10"/>
          <p:cNvCxnSpPr/>
          <p:nvPr/>
        </p:nvCxnSpPr>
        <p:spPr>
          <a:xfrm>
            <a:off x="8662219" y="3067943"/>
            <a:ext cx="550607" cy="93335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8866103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4109" y="3671876"/>
            <a:ext cx="3759087" cy="2520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ep 6: Assemb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Put the converter board</a:t>
            </a:r>
          </a:p>
          <a:p>
            <a:r>
              <a:rPr lang="en-US" dirty="0" smtClean="0"/>
              <a:t>Assemble y_ko_display_part5</a:t>
            </a:r>
          </a:p>
          <a:p>
            <a:r>
              <a:rPr lang="en-US" dirty="0" smtClean="0"/>
              <a:t>Connect the non-magnetic battery and converter board</a:t>
            </a:r>
            <a:endParaRPr lang="en-GB" dirty="0"/>
          </a:p>
        </p:txBody>
      </p:sp>
      <p:sp>
        <p:nvSpPr>
          <p:cNvPr id="5" name="TextBox 4"/>
          <p:cNvSpPr txBox="1"/>
          <p:nvPr/>
        </p:nvSpPr>
        <p:spPr>
          <a:xfrm>
            <a:off x="5133196" y="3352273"/>
            <a:ext cx="17214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onverter board</a:t>
            </a:r>
            <a:endParaRPr lang="en-GB" dirty="0"/>
          </a:p>
        </p:txBody>
      </p:sp>
      <p:cxnSp>
        <p:nvCxnSpPr>
          <p:cNvPr id="7" name="Straight Arrow Connector 6"/>
          <p:cNvCxnSpPr/>
          <p:nvPr/>
        </p:nvCxnSpPr>
        <p:spPr>
          <a:xfrm flipH="1">
            <a:off x="3706762" y="3656963"/>
            <a:ext cx="1529991" cy="111311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Picture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66746" y="3656963"/>
            <a:ext cx="4131321" cy="25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336068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ep7 : Assemb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Insert the optic HDMI cable to HDMI connector</a:t>
            </a:r>
          </a:p>
          <a:p>
            <a:r>
              <a:rPr lang="en-US" dirty="0" smtClean="0"/>
              <a:t>Assemble y_ko_display_part4</a:t>
            </a:r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9340" y="3656963"/>
            <a:ext cx="4131321" cy="2520000"/>
          </a:xfrm>
          <a:prstGeom prst="rect">
            <a:avLst/>
          </a:prstGeom>
        </p:spPr>
      </p:pic>
      <p:cxnSp>
        <p:nvCxnSpPr>
          <p:cNvPr id="5" name="Straight Arrow Connector 4"/>
          <p:cNvCxnSpPr/>
          <p:nvPr/>
        </p:nvCxnSpPr>
        <p:spPr>
          <a:xfrm flipH="1">
            <a:off x="3598608" y="3405070"/>
            <a:ext cx="1661650" cy="101321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5151235" y="3035738"/>
            <a:ext cx="18296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ptic HDMI cable</a:t>
            </a:r>
            <a:endParaRPr lang="en-GB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07032" y="3656962"/>
            <a:ext cx="3868249" cy="25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07268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1</TotalTime>
  <Words>220</Words>
  <Application>Microsoft Office PowerPoint</Application>
  <PresentationFormat>Widescreen</PresentationFormat>
  <Paragraphs>40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Manufacturing instructions for the OLED display </vt:lpstr>
      <vt:lpstr>Part lists</vt:lpstr>
      <vt:lpstr>Step 1. Replace ferrite inductor </vt:lpstr>
      <vt:lpstr>Step 2. 3D printing</vt:lpstr>
      <vt:lpstr>Step 3. Tapping </vt:lpstr>
      <vt:lpstr>Step 4: Assemble </vt:lpstr>
      <vt:lpstr>Step 5: Assemble</vt:lpstr>
      <vt:lpstr>Step 6: Assemble</vt:lpstr>
      <vt:lpstr>Step7 : Assemble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nKo</dc:creator>
  <cp:lastModifiedBy>YunKo</cp:lastModifiedBy>
  <cp:revision>16</cp:revision>
  <dcterms:created xsi:type="dcterms:W3CDTF">2018-08-16T09:20:56Z</dcterms:created>
  <dcterms:modified xsi:type="dcterms:W3CDTF">2018-08-17T13:02:53Z</dcterms:modified>
</cp:coreProperties>
</file>